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letter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972"/>
    <p:restoredTop sz="92691"/>
  </p:normalViewPr>
  <p:slideViewPr>
    <p:cSldViewPr>
      <p:cViewPr>
        <p:scale>
          <a:sx n="97" d="100"/>
          <a:sy n="97" d="100"/>
        </p:scale>
        <p:origin x="2968" y="-5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4F1CFB-92B5-B747-AA63-AC23A1DF653D}" type="datetimeFigureOut">
              <a:rPr lang="pt-BR" smtClean="0"/>
              <a:t>24/09/2025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309C4C-0CEA-4547-90AE-12B67AADA9B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792729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C309C4C-0CEA-4547-90AE-12B67AADA9B5}" type="slidenum">
              <a:rPr lang="pt-BR" smtClean="0"/>
              <a:t>1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075413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039B-F6FC-4C45-8D82-52A153074B2A}" type="datetimeFigureOut">
              <a:rPr lang="pt-BR" smtClean="0"/>
              <a:t>24/09/2025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EA5C8-CD60-4596-B519-7446FAD0D23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392601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039B-F6FC-4C45-8D82-52A153074B2A}" type="datetimeFigureOut">
              <a:rPr lang="pt-BR" smtClean="0"/>
              <a:t>24/09/2025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EA5C8-CD60-4596-B519-7446FAD0D23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23550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529167"/>
            <a:ext cx="1157288" cy="11269133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529167"/>
            <a:ext cx="3357563" cy="11269133"/>
          </a:xfrm>
        </p:spPr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039B-F6FC-4C45-8D82-52A153074B2A}" type="datetimeFigureOut">
              <a:rPr lang="pt-BR" smtClean="0"/>
              <a:t>24/09/2025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EA5C8-CD60-4596-B519-7446FAD0D23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84833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039B-F6FC-4C45-8D82-52A153074B2A}" type="datetimeFigureOut">
              <a:rPr lang="pt-BR" smtClean="0"/>
              <a:t>24/09/2025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EA5C8-CD60-4596-B519-7446FAD0D23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116116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9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039B-F6FC-4C45-8D82-52A153074B2A}" type="datetimeFigureOut">
              <a:rPr lang="pt-BR" smtClean="0"/>
              <a:t>24/09/2025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EA5C8-CD60-4596-B519-7446FAD0D23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33830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257176" y="3081869"/>
            <a:ext cx="2257425" cy="8716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2628901" y="3081869"/>
            <a:ext cx="2257425" cy="8716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039B-F6FC-4C45-8D82-52A153074B2A}" type="datetimeFigureOut">
              <a:rPr lang="pt-BR" smtClean="0"/>
              <a:t>24/09/2025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EA5C8-CD60-4596-B519-7446FAD0D23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64461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039B-F6FC-4C45-8D82-52A153074B2A}" type="datetimeFigureOut">
              <a:rPr lang="pt-BR" smtClean="0"/>
              <a:t>24/09/2025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EA5C8-CD60-4596-B519-7446FAD0D23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090957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039B-F6FC-4C45-8D82-52A153074B2A}" type="datetimeFigureOut">
              <a:rPr lang="pt-BR" smtClean="0"/>
              <a:t>24/09/2025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EA5C8-CD60-4596-B519-7446FAD0D23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24213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039B-F6FC-4C45-8D82-52A153074B2A}" type="datetimeFigureOut">
              <a:rPr lang="pt-BR" smtClean="0"/>
              <a:t>24/09/2025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EA5C8-CD60-4596-B519-7446FAD0D23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976781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8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2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039B-F6FC-4C45-8D82-52A153074B2A}" type="datetimeFigureOut">
              <a:rPr lang="pt-BR" smtClean="0"/>
              <a:t>24/09/2025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EA5C8-CD60-4596-B519-7446FAD0D23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01447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8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2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8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2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039B-F6FC-4C45-8D82-52A153074B2A}" type="datetimeFigureOut">
              <a:rPr lang="pt-BR" smtClean="0"/>
              <a:t>24/09/2025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EA5C8-CD60-4596-B519-7446FAD0D23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810686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23039B-F6FC-4C45-8D82-52A153074B2A}" type="datetimeFigureOut">
              <a:rPr lang="pt-BR" smtClean="0"/>
              <a:t>24/09/2025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8EA5C8-CD60-4596-B519-7446FAD0D23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339839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78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2" indent="-342892" algn="l" defTabSz="914378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1" indent="-285743" algn="l" defTabSz="914378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2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8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8" indent="-228594" algn="l" defTabSz="914378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5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8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2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Agrupar 13">
            <a:extLst>
              <a:ext uri="{FF2B5EF4-FFF2-40B4-BE49-F238E27FC236}">
                <a16:creationId xmlns:a16="http://schemas.microsoft.com/office/drawing/2014/main" id="{B93B0FF1-2F85-64CD-E541-B216363F12BA}"/>
              </a:ext>
            </a:extLst>
          </p:cNvPr>
          <p:cNvGrpSpPr/>
          <p:nvPr/>
        </p:nvGrpSpPr>
        <p:grpSpPr>
          <a:xfrm>
            <a:off x="809943" y="971600"/>
            <a:ext cx="5255468" cy="6369795"/>
            <a:chOff x="809943" y="971600"/>
            <a:chExt cx="5255468" cy="6369795"/>
          </a:xfrm>
        </p:grpSpPr>
        <p:sp>
          <p:nvSpPr>
            <p:cNvPr id="2" name="CaixaDeTexto 1">
              <a:extLst>
                <a:ext uri="{FF2B5EF4-FFF2-40B4-BE49-F238E27FC236}">
                  <a16:creationId xmlns:a16="http://schemas.microsoft.com/office/drawing/2014/main" id="{B3AAD79D-3D78-3E67-4AF1-874AA7209EF5}"/>
                </a:ext>
              </a:extLst>
            </p:cNvPr>
            <p:cNvSpPr txBox="1"/>
            <p:nvPr/>
          </p:nvSpPr>
          <p:spPr>
            <a:xfrm>
              <a:off x="809943" y="6362153"/>
              <a:ext cx="5255468" cy="9792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>
                <a:lnSpc>
                  <a:spcPts val="1400"/>
                </a:lnSpc>
                <a:spcBef>
                  <a:spcPts val="600"/>
                </a:spcBef>
                <a:spcAft>
                  <a:spcPts val="1200"/>
                </a:spcAft>
              </a:pPr>
              <a:r>
                <a:rPr lang="en-US" sz="1000" b="1" noProof="0" dirty="0">
                  <a:latin typeface="Palatino Linotype" panose="02040502050505030304" pitchFamily="18" charset="0"/>
                  <a:ea typeface="Palatino" pitchFamily="2" charset="77"/>
                </a:rPr>
                <a:t>Figure S1 - </a:t>
              </a:r>
              <a:r>
                <a:rPr lang="en-US" sz="1000" noProof="0" dirty="0">
                  <a:latin typeface="Palatino Linotype" panose="02040502050505030304" pitchFamily="18" charset="0"/>
                  <a:ea typeface="Palatino" pitchFamily="2" charset="77"/>
                </a:rPr>
                <a:t>Assay to confirm the sterility of enzyme extracts containing XynA1 and used to formulate bread dough. (A) Cell-free XynA1. (B) Culture of the </a:t>
              </a:r>
              <a:r>
                <a:rPr lang="en-US" sz="1000" i="1" noProof="0" dirty="0">
                  <a:latin typeface="Palatino Linotype" panose="02040502050505030304" pitchFamily="18" charset="0"/>
                  <a:ea typeface="Palatino" pitchFamily="2" charset="77"/>
                </a:rPr>
                <a:t>C. </a:t>
              </a:r>
              <a:r>
                <a:rPr lang="en-US" sz="1000" i="1" noProof="0" dirty="0" err="1">
                  <a:latin typeface="Palatino Linotype" panose="02040502050505030304" pitchFamily="18" charset="0"/>
                  <a:ea typeface="Palatino" pitchFamily="2" charset="77"/>
                </a:rPr>
                <a:t>vibrioides</a:t>
              </a:r>
              <a:r>
                <a:rPr lang="en-US" sz="1000" noProof="0" dirty="0">
                  <a:latin typeface="Palatino Linotype" panose="02040502050505030304" pitchFamily="18" charset="0"/>
                  <a:ea typeface="Palatino" pitchFamily="2" charset="77"/>
                </a:rPr>
                <a:t> strain (BS-</a:t>
              </a:r>
              <a:r>
                <a:rPr lang="en-US" sz="1000" i="1" noProof="0" dirty="0">
                  <a:latin typeface="Palatino Linotype" panose="02040502050505030304" pitchFamily="18" charset="0"/>
                  <a:ea typeface="Palatino" pitchFamily="2" charset="77"/>
                </a:rPr>
                <a:t>xynA1</a:t>
              </a:r>
              <a:r>
                <a:rPr lang="en-US" sz="1000" noProof="0" dirty="0">
                  <a:latin typeface="Palatino Linotype" panose="02040502050505030304" pitchFamily="18" charset="0"/>
                  <a:ea typeface="Palatino" pitchFamily="2" charset="77"/>
                </a:rPr>
                <a:t> no sterilized) inoculated as a positive control in PYE and LB. (C) Negative control, culture media without inoculum. Plates were incubated at 30 °C for 48 hours. The absence of viable bacteria was confirmed by the complete absence of bacterial growth in panel (A).</a:t>
              </a:r>
            </a:p>
          </p:txBody>
        </p:sp>
        <p:grpSp>
          <p:nvGrpSpPr>
            <p:cNvPr id="13" name="Agrupar 12">
              <a:extLst>
                <a:ext uri="{FF2B5EF4-FFF2-40B4-BE49-F238E27FC236}">
                  <a16:creationId xmlns:a16="http://schemas.microsoft.com/office/drawing/2014/main" id="{78438C35-0F49-1C7E-6127-607236B4E273}"/>
                </a:ext>
              </a:extLst>
            </p:cNvPr>
            <p:cNvGrpSpPr/>
            <p:nvPr/>
          </p:nvGrpSpPr>
          <p:grpSpPr>
            <a:xfrm>
              <a:off x="1340768" y="971600"/>
              <a:ext cx="3672408" cy="5224281"/>
              <a:chOff x="908720" y="467028"/>
              <a:chExt cx="4248472" cy="5728853"/>
            </a:xfrm>
          </p:grpSpPr>
          <p:sp>
            <p:nvSpPr>
              <p:cNvPr id="4" name="Retângulo 3">
                <a:extLst>
                  <a:ext uri="{FF2B5EF4-FFF2-40B4-BE49-F238E27FC236}">
                    <a16:creationId xmlns:a16="http://schemas.microsoft.com/office/drawing/2014/main" id="{2981A391-0B9F-F041-A313-9698A3B0166A}"/>
                  </a:ext>
                </a:extLst>
              </p:cNvPr>
              <p:cNvSpPr/>
              <p:nvPr/>
            </p:nvSpPr>
            <p:spPr>
              <a:xfrm>
                <a:off x="1484784" y="827585"/>
                <a:ext cx="3672408" cy="5368296"/>
              </a:xfrm>
              <a:prstGeom prst="rect">
                <a:avLst/>
              </a:prstGeom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0" dirty="0"/>
              </a:p>
            </p:txBody>
          </p:sp>
          <p:grpSp>
            <p:nvGrpSpPr>
              <p:cNvPr id="3" name="Agrupar 2">
                <a:extLst>
                  <a:ext uri="{FF2B5EF4-FFF2-40B4-BE49-F238E27FC236}">
                    <a16:creationId xmlns:a16="http://schemas.microsoft.com/office/drawing/2014/main" id="{4BC73162-3528-6A15-0FB6-A515D2A75CCB}"/>
                  </a:ext>
                </a:extLst>
              </p:cNvPr>
              <p:cNvGrpSpPr/>
              <p:nvPr/>
            </p:nvGrpSpPr>
            <p:grpSpPr>
              <a:xfrm>
                <a:off x="1583927" y="939582"/>
                <a:ext cx="3501257" cy="5144586"/>
                <a:chOff x="1583927" y="939582"/>
                <a:chExt cx="3501257" cy="5144586"/>
              </a:xfrm>
            </p:grpSpPr>
            <p:pic>
              <p:nvPicPr>
                <p:cNvPr id="17" name="Imagem 25" descr="62047000_1588240927977677_6112222109885267968_n">
                  <a:extLst>
                    <a:ext uri="{FF2B5EF4-FFF2-40B4-BE49-F238E27FC236}">
                      <a16:creationId xmlns:a16="http://schemas.microsoft.com/office/drawing/2014/main" id="{D3F30FDB-362E-715D-D022-BBC6FB31BA9C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047" t="17000" r="2831" b="16200"/>
                <a:stretch>
                  <a:fillRect/>
                </a:stretch>
              </p:blipFill>
              <p:spPr bwMode="auto">
                <a:xfrm>
                  <a:off x="1583927" y="939582"/>
                  <a:ext cx="3501257" cy="176980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8" name="Imagem 26" descr="69784552_2331667167083357_1978766474935795712_n (1)">
                  <a:extLst>
                    <a:ext uri="{FF2B5EF4-FFF2-40B4-BE49-F238E27FC236}">
                      <a16:creationId xmlns:a16="http://schemas.microsoft.com/office/drawing/2014/main" id="{FE38A712-E342-085E-A326-72DA94D2F26A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8482" r="2698" b="15848"/>
                <a:stretch>
                  <a:fillRect/>
                </a:stretch>
              </p:blipFill>
              <p:spPr bwMode="auto">
                <a:xfrm>
                  <a:off x="1583927" y="2709389"/>
                  <a:ext cx="3501257" cy="1665701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9" name="Imagem 28" descr="70187660_1356540387857470_1411613092856463360_n">
                  <a:extLst>
                    <a:ext uri="{FF2B5EF4-FFF2-40B4-BE49-F238E27FC236}">
                      <a16:creationId xmlns:a16="http://schemas.microsoft.com/office/drawing/2014/main" id="{D289E44D-6273-0B0E-17EB-13A7BC6AAF4B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95" t="13972" r="-27" b="16566"/>
                <a:stretch>
                  <a:fillRect/>
                </a:stretch>
              </p:blipFill>
              <p:spPr bwMode="auto">
                <a:xfrm>
                  <a:off x="1583927" y="4375089"/>
                  <a:ext cx="3501257" cy="1709079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5" name="Retângulo Arredondado 4">
                <a:extLst>
                  <a:ext uri="{FF2B5EF4-FFF2-40B4-BE49-F238E27FC236}">
                    <a16:creationId xmlns:a16="http://schemas.microsoft.com/office/drawing/2014/main" id="{FBFD166D-1402-B29A-C78E-E49E745E239D}"/>
                  </a:ext>
                </a:extLst>
              </p:cNvPr>
              <p:cNvSpPr/>
              <p:nvPr/>
            </p:nvSpPr>
            <p:spPr>
              <a:xfrm>
                <a:off x="1484784" y="467028"/>
                <a:ext cx="1800200" cy="248844"/>
              </a:xfrm>
              <a:prstGeom prst="round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noProof="0" dirty="0">
                    <a:latin typeface="Palatino Linotype" panose="02040502050505030304" pitchFamily="18" charset="0"/>
                  </a:rPr>
                  <a:t>PYE medium</a:t>
                </a:r>
              </a:p>
            </p:txBody>
          </p:sp>
          <p:sp>
            <p:nvSpPr>
              <p:cNvPr id="6" name="Retângulo Arredondado 5">
                <a:extLst>
                  <a:ext uri="{FF2B5EF4-FFF2-40B4-BE49-F238E27FC236}">
                    <a16:creationId xmlns:a16="http://schemas.microsoft.com/office/drawing/2014/main" id="{76A8CF34-4BB2-210F-A5CF-FCDCBE9663AE}"/>
                  </a:ext>
                </a:extLst>
              </p:cNvPr>
              <p:cNvSpPr/>
              <p:nvPr/>
            </p:nvSpPr>
            <p:spPr>
              <a:xfrm>
                <a:off x="3491125" y="467028"/>
                <a:ext cx="1594060" cy="248844"/>
              </a:xfrm>
              <a:prstGeom prst="round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noProof="0" dirty="0">
                    <a:latin typeface="Palatino Linotype" panose="02040502050505030304" pitchFamily="18" charset="0"/>
                  </a:rPr>
                  <a:t>LB medium</a:t>
                </a:r>
              </a:p>
            </p:txBody>
          </p:sp>
          <p:sp>
            <p:nvSpPr>
              <p:cNvPr id="7" name="Retângulo Arredondado 6">
                <a:extLst>
                  <a:ext uri="{FF2B5EF4-FFF2-40B4-BE49-F238E27FC236}">
                    <a16:creationId xmlns:a16="http://schemas.microsoft.com/office/drawing/2014/main" id="{2D80623B-C837-8C5B-0F3D-6F483AFE3337}"/>
                  </a:ext>
                </a:extLst>
              </p:cNvPr>
              <p:cNvSpPr/>
              <p:nvPr/>
            </p:nvSpPr>
            <p:spPr>
              <a:xfrm>
                <a:off x="908720" y="1763688"/>
                <a:ext cx="360040" cy="248908"/>
              </a:xfrm>
              <a:prstGeom prst="round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noProof="0" dirty="0">
                    <a:latin typeface="Palatino Linotype" panose="02040502050505030304" pitchFamily="18" charset="0"/>
                  </a:rPr>
                  <a:t>A</a:t>
                </a:r>
              </a:p>
            </p:txBody>
          </p:sp>
          <p:sp>
            <p:nvSpPr>
              <p:cNvPr id="11" name="Retângulo Arredondado 10">
                <a:extLst>
                  <a:ext uri="{FF2B5EF4-FFF2-40B4-BE49-F238E27FC236}">
                    <a16:creationId xmlns:a16="http://schemas.microsoft.com/office/drawing/2014/main" id="{25D5A894-44A9-3DC0-A96B-BFF6EFD68E49}"/>
                  </a:ext>
                </a:extLst>
              </p:cNvPr>
              <p:cNvSpPr/>
              <p:nvPr/>
            </p:nvSpPr>
            <p:spPr>
              <a:xfrm>
                <a:off x="908720" y="5105174"/>
                <a:ext cx="360040" cy="248908"/>
              </a:xfrm>
              <a:prstGeom prst="round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noProof="0" dirty="0">
                    <a:latin typeface="Palatino Linotype" panose="02040502050505030304" pitchFamily="18" charset="0"/>
                  </a:rPr>
                  <a:t>C</a:t>
                </a:r>
              </a:p>
            </p:txBody>
          </p:sp>
          <p:sp>
            <p:nvSpPr>
              <p:cNvPr id="12" name="Retângulo Arredondado 11">
                <a:extLst>
                  <a:ext uri="{FF2B5EF4-FFF2-40B4-BE49-F238E27FC236}">
                    <a16:creationId xmlns:a16="http://schemas.microsoft.com/office/drawing/2014/main" id="{9F76D963-8263-81E5-E457-9176873B809A}"/>
                  </a:ext>
                </a:extLst>
              </p:cNvPr>
              <p:cNvSpPr/>
              <p:nvPr/>
            </p:nvSpPr>
            <p:spPr>
              <a:xfrm>
                <a:off x="908720" y="3417785"/>
                <a:ext cx="360040" cy="248908"/>
              </a:xfrm>
              <a:prstGeom prst="round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noProof="0" dirty="0">
                    <a:latin typeface="Palatino Linotype" panose="02040502050505030304" pitchFamily="18" charset="0"/>
                  </a:rPr>
                  <a:t>B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74959866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57</TotalTime>
  <Words>100</Words>
  <Application>Microsoft Macintosh PowerPoint</Application>
  <PresentationFormat>Papel Carta (216 x 279 mm)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Palatino Linotype</vt:lpstr>
      <vt:lpstr>Tema do Offic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Waleska</dc:creator>
  <cp:lastModifiedBy>Rita de Cassia Garcia Simao</cp:lastModifiedBy>
  <cp:revision>90</cp:revision>
  <dcterms:created xsi:type="dcterms:W3CDTF">2018-09-22T23:31:50Z</dcterms:created>
  <dcterms:modified xsi:type="dcterms:W3CDTF">2025-09-24T13:21:42Z</dcterms:modified>
</cp:coreProperties>
</file>